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108" y="7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9778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8141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2075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1557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73971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04639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44554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98220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36149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2524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02742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0369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09817" y="2074094"/>
            <a:ext cx="5579833" cy="347036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827231" y="1767788"/>
            <a:ext cx="5898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     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     Normal control  (101)         Extra pulmonary (120)           Pulmonary only ( 106)</a:t>
            </a:r>
          </a:p>
        </p:txBody>
      </p:sp>
      <p:cxnSp>
        <p:nvCxnSpPr>
          <p:cNvPr id="3" name="Straight Connector 2"/>
          <p:cNvCxnSpPr/>
          <p:nvPr/>
        </p:nvCxnSpPr>
        <p:spPr>
          <a:xfrm>
            <a:off x="5015699" y="1767788"/>
            <a:ext cx="0" cy="39179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6920699" y="1843988"/>
            <a:ext cx="0" cy="39179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8625674" y="1843988"/>
            <a:ext cx="0" cy="39179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3309817" y="1843988"/>
            <a:ext cx="0" cy="39179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 rot="16200000">
            <a:off x="8396819" y="2470737"/>
            <a:ext cx="10395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ow            High</a:t>
            </a:r>
          </a:p>
        </p:txBody>
      </p:sp>
      <p:sp>
        <p:nvSpPr>
          <p:cNvPr id="14" name="Rectangle 13"/>
          <p:cNvSpPr/>
          <p:nvPr/>
        </p:nvSpPr>
        <p:spPr>
          <a:xfrm>
            <a:off x="514349" y="642932"/>
            <a:ext cx="11020425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Fig 1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.  The </a:t>
            </a:r>
            <a:r>
              <a:rPr kumimoji="0" lang="en-US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eatmap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of 120 IgG autoantigen shows reactivity expressed in terms of row z-score for a respective antigen across different patient samples. Each row in the graphics represent an antigen for serum specimens organized into columns classified as normal control (n = 101), extra pulmonary sarcoidosis (n = 120), and pulmonary only sarcoidosis (n = 106).  The reactivity intensity ranges from blue (low) to white (moderate) or red (high).  </a:t>
            </a:r>
          </a:p>
        </p:txBody>
      </p:sp>
    </p:spTree>
    <p:extLst>
      <p:ext uri="{BB962C8B-B14F-4D97-AF65-F5344CB8AC3E}">
        <p14:creationId xmlns:p14="http://schemas.microsoft.com/office/powerpoint/2010/main" val="3562826280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4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1_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mzeh, Nabeel Y</dc:creator>
  <cp:lastModifiedBy>Hamzeh, Nabeel Y</cp:lastModifiedBy>
  <cp:revision>1</cp:revision>
  <dcterms:created xsi:type="dcterms:W3CDTF">2022-09-27T14:04:57Z</dcterms:created>
  <dcterms:modified xsi:type="dcterms:W3CDTF">2022-09-27T14:05:26Z</dcterms:modified>
</cp:coreProperties>
</file>